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-102" y="-114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3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Объект 2">
            <a:extLst>
              <a:ext uri="{FF2B5EF4-FFF2-40B4-BE49-F238E27FC236}">
                <a16:creationId xmlns:a16="http://schemas.microsoft.com/office/drawing/2014/main" xmlns="" id="{B5A1926C-F1CF-5BDA-0061-F4962B0CECDA}"/>
              </a:ext>
            </a:extLst>
          </p:cNvPr>
          <p:cNvSpPr txBox="1">
            <a:spLocks/>
          </p:cNvSpPr>
          <p:nvPr/>
        </p:nvSpPr>
        <p:spPr>
          <a:xfrm>
            <a:off x="155448" y="5943600"/>
            <a:ext cx="8862822" cy="762000"/>
          </a:xfrm>
          <a:prstGeom prst="rect">
            <a:avLst/>
          </a:prstGeom>
        </p:spPr>
        <p:txBody>
          <a:bodyPr vert="horz" lIns="91440" tIns="45720" rIns="91440" bIns="45720" rtlCol="0">
            <a:normAutofit fontScale="85000" lnSpcReduction="10000"/>
          </a:bodyPr>
          <a:lstStyle>
            <a:lvl1pPr marL="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32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  <a:lvl2pPr marL="457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8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2pPr>
            <a:lvl3pPr marL="914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4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3pPr>
            <a:lvl4pPr marL="1371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4pPr>
            <a:lvl5pPr marL="18288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5pPr>
            <a:lvl6pPr marL="22860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6pPr>
            <a:lvl7pPr marL="27432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7pPr>
            <a:lvl8pPr marL="32004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8pPr>
            <a:lvl9pPr marL="3657600" indent="0" algn="ctr" defTabSz="914400" rtl="0" eaLnBrk="1" latinLnBrk="0" hangingPunct="1">
              <a:spcBef>
                <a:spcPct val="20000"/>
              </a:spcBef>
              <a:buFont typeface="Arial" pitchFamily="34" charset="0"/>
              <a:buNone/>
              <a:defRPr sz="2000" kern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hematic comparison of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Gs in IS-s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R-s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IA-s vs. IR-s pairwise comparisons in striatum, as well as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-f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s.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R-f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d IA-f vs. IR-f pairwise comparisons in FC are presented using a 4-set Venn diagram. The number of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Gs is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dicated using numbers on the chart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gments. (</a:t>
            </a:r>
            <a:r>
              <a:rPr lang="en-US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 Hierarchical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uster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alysis </a:t>
            </a:r>
            <a:r>
              <a:rPr lang="en-US" sz="14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presents 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1 DEGs that lie within the intersection on Venn diagram (</a:t>
            </a:r>
            <a:r>
              <a:rPr lang="en-US" sz="1400" b="1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. Only those genes with cut-off &gt;1.5 and </a:t>
            </a:r>
            <a:r>
              <a:rPr lang="en-US" sz="1400" i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adj</a:t>
            </a:r>
            <a:r>
              <a:rPr lang="en-US" sz="14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&lt; 0.05 were selected as significant results.</a:t>
            </a:r>
            <a:endParaRPr lang="ru-RU" sz="14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Прямоугольник 8"/>
          <p:cNvSpPr/>
          <p:nvPr/>
        </p:nvSpPr>
        <p:spPr>
          <a:xfrm>
            <a:off x="169865" y="76200"/>
            <a:ext cx="874553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400" b="1" smtClean="0">
                <a:latin typeface="Arial" panose="020B0604020202020204" pitchFamily="34" charset="0"/>
                <a:cs typeface="Arial" panose="020B0604020202020204" pitchFamily="34" charset="0"/>
              </a:rPr>
              <a:t>S3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mparison of RNA-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eq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sults under </a:t>
            </a:r>
            <a:r>
              <a:rPr 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max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and ACTH(6-9)PGP peptides action in striatum and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C at 24 h after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MCAO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400" b="1" dirty="0">
              <a:latin typeface="Arial" panose="020B0604020202020204" pitchFamily="34" charset="0"/>
              <a:ea typeface="+mj-ea"/>
              <a:cs typeface="Arial" panose="020B0604020202020204" pitchFamily="34" charset="0"/>
            </a:endParaRPr>
          </a:p>
        </p:txBody>
      </p:sp>
      <p:pic>
        <p:nvPicPr>
          <p:cNvPr id="1026" name="Picture 2" descr="K:\Редактируемые\Для публикаций\0_текущие публикации\ишемия_2\стриатум 24h\статья по 24 часам striat\2_pept-str\fs3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62000" y="1219200"/>
            <a:ext cx="7798688" cy="40878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227907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</TotalTime>
  <Words>116</Words>
  <Application>Microsoft Office PowerPoint</Application>
  <PresentationFormat>Экран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Office Them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12</cp:revision>
  <dcterms:created xsi:type="dcterms:W3CDTF">2006-08-16T00:00:00Z</dcterms:created>
  <dcterms:modified xsi:type="dcterms:W3CDTF">2025-03-03T16:34:48Z</dcterms:modified>
</cp:coreProperties>
</file>